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72" r:id="rId5"/>
    <p:sldId id="259" r:id="rId6"/>
    <p:sldId id="262" r:id="rId7"/>
    <p:sldId id="263" r:id="rId8"/>
    <p:sldId id="264" r:id="rId9"/>
    <p:sldId id="265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hmad Mohammad I. Alqudah" userId="33bcb799-8290-410a-b32c-aeb244955d6d" providerId="ADAL" clId="{96160319-6385-47CD-BDBF-638C075485BD}"/>
    <pc:docChg chg="addSld delSld modSld">
      <pc:chgData name="Ahmad Mohammad I. Alqudah" userId="33bcb799-8290-410a-b32c-aeb244955d6d" providerId="ADAL" clId="{96160319-6385-47CD-BDBF-638C075485BD}" dt="2024-08-18T15:49:18.632" v="1"/>
      <pc:docMkLst>
        <pc:docMk/>
      </pc:docMkLst>
      <pc:sldChg chg="add">
        <pc:chgData name="Ahmad Mohammad I. Alqudah" userId="33bcb799-8290-410a-b32c-aeb244955d6d" providerId="ADAL" clId="{96160319-6385-47CD-BDBF-638C075485BD}" dt="2024-08-18T15:49:18.632" v="1"/>
        <pc:sldMkLst>
          <pc:docMk/>
          <pc:sldMk cId="2691670623" sldId="259"/>
        </pc:sldMkLst>
      </pc:sldChg>
      <pc:sldChg chg="add">
        <pc:chgData name="Ahmad Mohammad I. Alqudah" userId="33bcb799-8290-410a-b32c-aeb244955d6d" providerId="ADAL" clId="{96160319-6385-47CD-BDBF-638C075485BD}" dt="2024-08-18T15:49:18.632" v="1"/>
        <pc:sldMkLst>
          <pc:docMk/>
          <pc:sldMk cId="2934857333" sldId="262"/>
        </pc:sldMkLst>
      </pc:sldChg>
      <pc:sldChg chg="add">
        <pc:chgData name="Ahmad Mohammad I. Alqudah" userId="33bcb799-8290-410a-b32c-aeb244955d6d" providerId="ADAL" clId="{96160319-6385-47CD-BDBF-638C075485BD}" dt="2024-08-18T15:49:18.632" v="1"/>
        <pc:sldMkLst>
          <pc:docMk/>
          <pc:sldMk cId="3634446421" sldId="263"/>
        </pc:sldMkLst>
      </pc:sldChg>
      <pc:sldChg chg="add">
        <pc:chgData name="Ahmad Mohammad I. Alqudah" userId="33bcb799-8290-410a-b32c-aeb244955d6d" providerId="ADAL" clId="{96160319-6385-47CD-BDBF-638C075485BD}" dt="2024-08-18T15:49:18.632" v="1"/>
        <pc:sldMkLst>
          <pc:docMk/>
          <pc:sldMk cId="2600825520" sldId="264"/>
        </pc:sldMkLst>
      </pc:sldChg>
      <pc:sldChg chg="add">
        <pc:chgData name="Ahmad Mohammad I. Alqudah" userId="33bcb799-8290-410a-b32c-aeb244955d6d" providerId="ADAL" clId="{96160319-6385-47CD-BDBF-638C075485BD}" dt="2024-08-18T15:49:18.632" v="1"/>
        <pc:sldMkLst>
          <pc:docMk/>
          <pc:sldMk cId="1283777331" sldId="26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30AB4-A940-4BD2-82D0-B3E386EA8F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841494-E320-4F3E-82FF-6B4AE6FB1B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3E3386-9A96-45FF-996A-AB4921578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CC3F33-D211-4E9C-BA4B-D7BA22BDAF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09223A-EEF4-4C15-9DC5-2ABB498D9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740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3CAC3A-C55B-48F6-9194-5960332D73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602037-EC08-4EFC-ACB5-44017D7935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3A7266-2515-4F83-B1DD-965521DEB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82B606-702F-465F-A791-2CAEBCF46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94EC6D-3FBB-4AC7-B367-6AD5BE634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248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0D2A6A-9E4E-4F45-91E7-E944FBC752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556679-2292-4A74-9DC8-3512020286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162E08-95EC-4F02-A268-FDCB75795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C2443A-2829-4CD5-B53C-8072B8784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84B233-FD30-4519-B910-81BA882CC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655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6CFBD2-300F-4518-84E9-00A3F021B4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417931-DB46-49E0-9E02-D83C96D8BB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A52693-8C28-4611-A4FE-C3EA35AE8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C6E299-0167-407B-A91F-EC1B52052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50F16-C991-4A46-BA5F-8C325A9CA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507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A8450-10B7-4E6D-B73E-11366EED5C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1BDAEC-8439-42B9-9793-BA39FAA074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18A595-F598-4536-8F53-4B5350451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94F7F5-2E09-4E7F-AF18-96CA9A79A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FD2135-FA75-49D9-9E37-7C0D25373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11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6AEDB6-FCF1-4F91-A8C5-1C9CCE0483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48CD5D-F9B1-47E7-8705-F32A37CBB1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6B7085-A8AE-4A94-8F31-1C294002A8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30717C-FA71-48B1-8655-6CD649F90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16B3C9-274A-4001-89D8-B83EAC80C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3ADBC6-3223-43B3-9661-53A51D59B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833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25CF8-5FD5-40B0-81C2-ADB900C66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00E1B9-6E75-4110-8C70-8D15960F55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01D008-CE35-4CE6-9374-E8DB8B18F4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C73373-31EA-4E5F-97EB-B3FD357A31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7D1EAF-F971-4F80-B072-21DF65DD45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BF0470-F473-4576-8B03-A66E93450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8D8358-F051-4556-ADEC-A928CEBE6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002A38-3317-4CF4-838E-C2B400F64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874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2665A-839A-461D-8B9A-B38064F34C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5AA4A2-11D5-466F-8CD8-A392A7F9C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8AD063-1ADC-4A99-A2D6-3FB2DECDF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DB92EE-8836-4B18-AE3E-7D7D3AD56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082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E3771E-42E4-4458-BBC9-BFCF673D8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B095D74-E2BF-4C57-B039-60A0575B0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3C54D1-F017-4110-BB92-51575775D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859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E1C4E4-B24A-4881-939E-745BF5EFE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7FF5A8-8DF0-4233-BF45-73436A12AE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4C55A1-870E-4CB1-B4C6-13603AFB27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5D95E7-C8B8-480F-9D13-FFE8483F9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8E704D-CEEF-4822-AB67-D098F1017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09B256-8EB5-41A0-AE35-AC5803C9D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05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B0F0A-0671-40DE-955E-0AB8563679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FEA1D5-2E08-4978-80D9-145B640407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C543FF-E812-4B6D-9A3F-16BE4B2FCA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D73E61-37DB-4693-A27D-2D43A71C1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44D680-C5E5-4AC0-A2FB-B3FA113D7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A2C570-ED95-4736-A533-41DBBAA10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980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30AB2FF-CB45-4B0F-B963-2E0B92D73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58AB0E-70F4-463A-B049-64E05BCDB3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F0C869-98C2-4997-8904-51CA18AF42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57FAD-AA90-4CAC-90AA-9F4A360A1BFE}" type="datetimeFigureOut">
              <a:rPr lang="en-US" smtClean="0"/>
              <a:t>8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FB80D-EDA0-45C2-AEFF-47D9584C5D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E6B312-53AB-402B-865A-8DB214DA61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A5731A-B32F-4290-99FF-2AF2365052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080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emf"/><Relationship Id="rId4" Type="http://schemas.openxmlformats.org/officeDocument/2006/relationships/image" Target="../media/image12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jpg"/><Relationship Id="rId4" Type="http://schemas.openxmlformats.org/officeDocument/2006/relationships/image" Target="../media/image16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jpg"/><Relationship Id="rId4" Type="http://schemas.openxmlformats.org/officeDocument/2006/relationships/image" Target="../media/image2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0178D8F3-D196-4112-AFA3-EB4E673FEA6E}"/>
              </a:ext>
            </a:extLst>
          </p:cNvPr>
          <p:cNvSpPr/>
          <p:nvPr/>
        </p:nvSpPr>
        <p:spPr>
          <a:xfrm>
            <a:off x="0" y="5587166"/>
            <a:ext cx="12082622" cy="2866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Accumulation of different Amylase trypsin inhibitors (ATIs) in 184 spring barley genotypes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6B4799F-DCFE-4ED8-A676-41DA1ABEF777}"/>
              </a:ext>
            </a:extLst>
          </p:cNvPr>
          <p:cNvGrpSpPr/>
          <p:nvPr/>
        </p:nvGrpSpPr>
        <p:grpSpPr>
          <a:xfrm>
            <a:off x="0" y="1270834"/>
            <a:ext cx="12192000" cy="4316333"/>
            <a:chOff x="0" y="1039412"/>
            <a:chExt cx="17373600" cy="615077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3B7BE0F-5C09-4CC6-896E-8B0826D90B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039412"/>
              <a:ext cx="17373600" cy="615077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0D4A9B6-45A7-4C62-B58D-3F308D9AFB23}"/>
                </a:ext>
              </a:extLst>
            </p:cNvPr>
            <p:cNvSpPr txBox="1"/>
            <p:nvPr/>
          </p:nvSpPr>
          <p:spPr>
            <a:xfrm rot="16200000">
              <a:off x="16695770" y="6509450"/>
              <a:ext cx="546399" cy="300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77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02</a:t>
              </a:r>
              <a:endParaRPr lang="en-US" sz="77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662411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D076B24-A96D-4B9A-8BAF-660E91861E2F}"/>
              </a:ext>
            </a:extLst>
          </p:cNvPr>
          <p:cNvSpPr/>
          <p:nvPr/>
        </p:nvSpPr>
        <p:spPr>
          <a:xfrm>
            <a:off x="0" y="5863014"/>
            <a:ext cx="12192000" cy="4810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Manhattan plots showing significant marker traits association and </a:t>
            </a:r>
            <a:r>
              <a:rPr lang="it-IT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le-Quantile (Q-Q) for Farm-CPU model</a:t>
            </a:r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a) AI.BDAI and b) AI.BMAI in 184 spring barley genotypes (P&lt;0.0001; -log</a:t>
            </a:r>
            <a:r>
              <a:rPr lang="en-US" sz="1263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 FDR). Red line represents the expected values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A98E6A6-4F8D-4E6D-A64C-DD813734152A}"/>
              </a:ext>
            </a:extLst>
          </p:cNvPr>
          <p:cNvGrpSpPr/>
          <p:nvPr/>
        </p:nvGrpSpPr>
        <p:grpSpPr>
          <a:xfrm>
            <a:off x="396831" y="541422"/>
            <a:ext cx="9345703" cy="5321592"/>
            <a:chOff x="565484" y="0"/>
            <a:chExt cx="13317626" cy="7583269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374CB1C-3001-4828-B297-3357FB557F40}"/>
                </a:ext>
              </a:extLst>
            </p:cNvPr>
            <p:cNvGrpSpPr/>
            <p:nvPr/>
          </p:nvGrpSpPr>
          <p:grpSpPr>
            <a:xfrm>
              <a:off x="565484" y="0"/>
              <a:ext cx="13018264" cy="7583269"/>
              <a:chOff x="565484" y="0"/>
              <a:chExt cx="13018264" cy="7583269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1EF0D9EF-2987-4ED8-BB17-2BC50DC41F04}"/>
                  </a:ext>
                </a:extLst>
              </p:cNvPr>
              <p:cNvGrpSpPr/>
              <p:nvPr/>
            </p:nvGrpSpPr>
            <p:grpSpPr>
              <a:xfrm>
                <a:off x="565484" y="0"/>
                <a:ext cx="13018264" cy="7583269"/>
                <a:chOff x="565484" y="0"/>
                <a:chExt cx="13018264" cy="7583269"/>
              </a:xfrm>
            </p:grpSpPr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7F1CCD18-39E5-4A3D-902D-030FF2DEBC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983748" y="146338"/>
                  <a:ext cx="3600000" cy="3600000"/>
                </a:xfrm>
                <a:prstGeom prst="rect">
                  <a:avLst/>
                </a:prstGeom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4529AB36-2554-4837-938A-983DCB9CBC0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65484" y="0"/>
                  <a:ext cx="9240000" cy="3960000"/>
                </a:xfrm>
                <a:prstGeom prst="rect">
                  <a:avLst/>
                </a:prstGeom>
              </p:spPr>
            </p:pic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902AA067-E9BC-47D5-BF4A-D898E0C5E2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983748" y="3960000"/>
                  <a:ext cx="3600000" cy="3600000"/>
                </a:xfrm>
                <a:prstGeom prst="rect">
                  <a:avLst/>
                </a:prstGeom>
              </p:spPr>
            </p:pic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A410E665-2D2A-43AF-9814-ACC2866E31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65484" y="3623269"/>
                  <a:ext cx="9240000" cy="3960000"/>
                </a:xfrm>
                <a:prstGeom prst="rect">
                  <a:avLst/>
                </a:prstGeom>
              </p:spPr>
            </p:pic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B31BAB4-295F-4D6A-8644-B5D4B464BC96}"/>
                  </a:ext>
                </a:extLst>
              </p:cNvPr>
              <p:cNvSpPr txBox="1"/>
              <p:nvPr/>
            </p:nvSpPr>
            <p:spPr>
              <a:xfrm>
                <a:off x="7976937" y="240633"/>
                <a:ext cx="1055794" cy="377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23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I.BDAI</a:t>
                </a:r>
                <a:endParaRPr lang="en-US" sz="112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1C89A67-6D6D-4F5D-B607-B3C2375B7403}"/>
                  </a:ext>
                </a:extLst>
              </p:cNvPr>
              <p:cNvSpPr txBox="1"/>
              <p:nvPr/>
            </p:nvSpPr>
            <p:spPr>
              <a:xfrm>
                <a:off x="7953693" y="4031355"/>
                <a:ext cx="1101481" cy="377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23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I.BMAI</a:t>
                </a:r>
                <a:endParaRPr lang="en-US" sz="112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82F559E-A5E0-4B32-8705-F2A2196C44BC}"/>
                </a:ext>
              </a:extLst>
            </p:cNvPr>
            <p:cNvSpPr txBox="1"/>
            <p:nvPr/>
          </p:nvSpPr>
          <p:spPr>
            <a:xfrm>
              <a:off x="13402801" y="55965"/>
              <a:ext cx="443608" cy="562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96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965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301D9FE-CED3-4DF5-8FEA-D92CF977555E}"/>
                </a:ext>
              </a:extLst>
            </p:cNvPr>
            <p:cNvSpPr txBox="1"/>
            <p:nvPr/>
          </p:nvSpPr>
          <p:spPr>
            <a:xfrm>
              <a:off x="13439502" y="4000577"/>
              <a:ext cx="443608" cy="562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96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965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916706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6E5ED86-5D75-4DC6-8AF3-0C21598E19D0}"/>
              </a:ext>
            </a:extLst>
          </p:cNvPr>
          <p:cNvSpPr/>
          <p:nvPr/>
        </p:nvSpPr>
        <p:spPr>
          <a:xfrm>
            <a:off x="0" y="5863014"/>
            <a:ext cx="12192000" cy="4810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Manhattan plots showing significant marker traits association and Quantile-Quantile (Q-Q) for Farm-CPU model for a) ASI and b) </a:t>
            </a:r>
            <a:r>
              <a:rPr lang="en-US" sz="1263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I_total</a:t>
            </a:r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184 spring barley genotypes (P&lt;0.0001; -log10&gt; FDR). Red line represents the expected values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E3C8070-815E-44A4-A987-81828F8DA011}"/>
              </a:ext>
            </a:extLst>
          </p:cNvPr>
          <p:cNvGrpSpPr/>
          <p:nvPr/>
        </p:nvGrpSpPr>
        <p:grpSpPr>
          <a:xfrm>
            <a:off x="1009142" y="541421"/>
            <a:ext cx="9194040" cy="5310655"/>
            <a:chOff x="1438027" y="0"/>
            <a:chExt cx="13101507" cy="7567683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475694F7-CCEF-478B-AB00-F52DA975743D}"/>
                </a:ext>
              </a:extLst>
            </p:cNvPr>
            <p:cNvGrpSpPr/>
            <p:nvPr/>
          </p:nvGrpSpPr>
          <p:grpSpPr>
            <a:xfrm>
              <a:off x="1438027" y="0"/>
              <a:ext cx="12840000" cy="7567683"/>
              <a:chOff x="1438027" y="0"/>
              <a:chExt cx="12840000" cy="7567683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41EC0193-8BA1-4EF6-8699-05582285815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678027" y="180000"/>
                <a:ext cx="3600000" cy="3600000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8E5C9651-1F74-4DFD-9F5A-9DC556BEAA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38027" y="0"/>
                <a:ext cx="9240000" cy="3960000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735033E1-15EC-4416-9985-0E55D429BA19}"/>
                  </a:ext>
                </a:extLst>
              </p:cNvPr>
              <p:cNvSpPr txBox="1"/>
              <p:nvPr/>
            </p:nvSpPr>
            <p:spPr>
              <a:xfrm>
                <a:off x="9225622" y="323362"/>
                <a:ext cx="605790" cy="377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23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I</a:t>
                </a:r>
                <a:endParaRPr lang="en-US" sz="112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EDB9BBB3-7F0D-4C67-AAF0-1C02B4D8AC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678027" y="3780000"/>
                <a:ext cx="3600000" cy="360000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C8FAA68A-B069-4815-B080-018D16A06C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38027" y="3607683"/>
                <a:ext cx="9240000" cy="3960000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2B7E569-A903-458F-80C3-91E8A758061F}"/>
                  </a:ext>
                </a:extLst>
              </p:cNvPr>
              <p:cNvSpPr txBox="1"/>
              <p:nvPr/>
            </p:nvSpPr>
            <p:spPr>
              <a:xfrm>
                <a:off x="8970361" y="3993993"/>
                <a:ext cx="1131175" cy="377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23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I_total</a:t>
                </a:r>
                <a:endParaRPr lang="de-DE" sz="112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240D508-24D6-4D52-9C5C-FE0D11D0BFD1}"/>
                </a:ext>
              </a:extLst>
            </p:cNvPr>
            <p:cNvSpPr txBox="1"/>
            <p:nvPr/>
          </p:nvSpPr>
          <p:spPr>
            <a:xfrm>
              <a:off x="14095926" y="61752"/>
              <a:ext cx="443608" cy="562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96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965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103B6DA-FC19-4ABC-8658-D54643706758}"/>
                </a:ext>
              </a:extLst>
            </p:cNvPr>
            <p:cNvSpPr txBox="1"/>
            <p:nvPr/>
          </p:nvSpPr>
          <p:spPr>
            <a:xfrm>
              <a:off x="14095926" y="3721659"/>
              <a:ext cx="443608" cy="562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96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965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348573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F097BA4-2581-478A-A7AE-E38D94F8D0B2}"/>
              </a:ext>
            </a:extLst>
          </p:cNvPr>
          <p:cNvSpPr/>
          <p:nvPr/>
        </p:nvSpPr>
        <p:spPr>
          <a:xfrm>
            <a:off x="0" y="5863014"/>
            <a:ext cx="12192000" cy="4810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Manhattan plots showing significant marker traits association and Quantile-Quantile (Q-Q) for Farm-CPU model for a) </a:t>
            </a:r>
            <a:r>
              <a:rPr lang="en-US" sz="1263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TI_CMc</a:t>
            </a:r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) CI_2 in 184 spring barley genotypes (P&lt;0.0001; -log10&gt; FDR). Red line represents the expected values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36495AD-7D94-48AB-B07F-BD1B580F9A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6720" y="541421"/>
            <a:ext cx="6484211" cy="277894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2A3830D-4D72-4500-AEE9-2DDE720B2A64}"/>
              </a:ext>
            </a:extLst>
          </p:cNvPr>
          <p:cNvSpPr txBox="1"/>
          <p:nvPr/>
        </p:nvSpPr>
        <p:spPr>
          <a:xfrm>
            <a:off x="6474122" y="768343"/>
            <a:ext cx="809837" cy="2651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TI_CMc</a:t>
            </a:r>
            <a:endParaRPr lang="en-US" sz="11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06816AE-341B-4836-8972-9159E7B9AE4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3744" y="3320368"/>
            <a:ext cx="2526316" cy="252631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CF9AC8C-DF00-4CC1-BA79-107DE5CD9FD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6720" y="3088117"/>
            <a:ext cx="6484211" cy="277894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D9023C1-F1D7-40CB-83D7-E8E2ECC0456B}"/>
              </a:ext>
            </a:extLst>
          </p:cNvPr>
          <p:cNvSpPr txBox="1"/>
          <p:nvPr/>
        </p:nvSpPr>
        <p:spPr>
          <a:xfrm>
            <a:off x="6633859" y="3300051"/>
            <a:ext cx="489236" cy="2651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_2</a:t>
            </a:r>
            <a:endParaRPr lang="en-US" sz="11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C46AE8F-D35E-494C-A0A6-58ABB9B42C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36954" y="655996"/>
            <a:ext cx="2633107" cy="256673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5E83153-7E11-40E8-AFEF-7331F7BDF848}"/>
              </a:ext>
            </a:extLst>
          </p:cNvPr>
          <p:cNvSpPr txBox="1"/>
          <p:nvPr/>
        </p:nvSpPr>
        <p:spPr>
          <a:xfrm>
            <a:off x="10242270" y="644144"/>
            <a:ext cx="311304" cy="394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965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965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6773424-4AA1-4D40-9D74-21A8F269A286}"/>
              </a:ext>
            </a:extLst>
          </p:cNvPr>
          <p:cNvSpPr txBox="1"/>
          <p:nvPr/>
        </p:nvSpPr>
        <p:spPr>
          <a:xfrm>
            <a:off x="10242270" y="3051670"/>
            <a:ext cx="311304" cy="3947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965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965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44464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613AD3B5-3030-4EAB-860E-2A6E003E8EEF}"/>
              </a:ext>
            </a:extLst>
          </p:cNvPr>
          <p:cNvSpPr/>
          <p:nvPr/>
        </p:nvSpPr>
        <p:spPr>
          <a:xfrm>
            <a:off x="0" y="5895840"/>
            <a:ext cx="12192000" cy="6753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Manhattan plots showing significant marker traits association and Quantile-Quantile (Q-Q) for Farm-CPU model for a) </a:t>
            </a:r>
            <a:r>
              <a:rPr lang="en-US" sz="1263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Mc</a:t>
            </a:r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) </a:t>
            </a:r>
            <a:r>
              <a:rPr lang="en-US" sz="1263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Md</a:t>
            </a:r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184 spring barley genotypes (P&lt;0.0001; -log10&gt; FDR). Red line represents the expected values.</a:t>
            </a:r>
          </a:p>
          <a:p>
            <a:endParaRPr lang="en-US" sz="126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70BD83E-C5E7-46D0-8E18-24B94B82D03F}"/>
              </a:ext>
            </a:extLst>
          </p:cNvPr>
          <p:cNvGrpSpPr/>
          <p:nvPr/>
        </p:nvGrpSpPr>
        <p:grpSpPr>
          <a:xfrm>
            <a:off x="1224355" y="575527"/>
            <a:ext cx="9302837" cy="5375946"/>
            <a:chOff x="1744706" y="48600"/>
            <a:chExt cx="13256542" cy="7660723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615B9593-177F-47A2-B636-6EAEE195003F}"/>
                </a:ext>
              </a:extLst>
            </p:cNvPr>
            <p:cNvGrpSpPr/>
            <p:nvPr/>
          </p:nvGrpSpPr>
          <p:grpSpPr>
            <a:xfrm>
              <a:off x="1744706" y="48600"/>
              <a:ext cx="13008568" cy="7660723"/>
              <a:chOff x="1744706" y="48600"/>
              <a:chExt cx="13008568" cy="7660723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882C161A-5394-4FB9-B019-B0466CC511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153274" y="228600"/>
                <a:ext cx="3600000" cy="360000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8431A21-5761-4002-9EEE-E4C8E49CC6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44706" y="48600"/>
                <a:ext cx="9240000" cy="3960000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2465B9B6-125E-4AC6-BD1E-08D04085E719}"/>
                  </a:ext>
                </a:extLst>
              </p:cNvPr>
              <p:cNvSpPr txBox="1"/>
              <p:nvPr/>
            </p:nvSpPr>
            <p:spPr>
              <a:xfrm>
                <a:off x="9525439" y="228600"/>
                <a:ext cx="708584" cy="377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23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a</a:t>
                </a:r>
                <a:endParaRPr lang="en-US" sz="112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989ECEE3-A20F-4F90-80D0-516D147E50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153274" y="3929323"/>
                <a:ext cx="3600000" cy="3600000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BBE26A6C-EE20-497F-87D9-F0FFA939625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44706" y="3749323"/>
                <a:ext cx="9240000" cy="3960000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455BA46-CAD9-4293-9080-B3F0108715B3}"/>
                  </a:ext>
                </a:extLst>
              </p:cNvPr>
              <p:cNvSpPr txBox="1"/>
              <p:nvPr/>
            </p:nvSpPr>
            <p:spPr>
              <a:xfrm>
                <a:off x="9514218" y="4321823"/>
                <a:ext cx="720005" cy="377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23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d</a:t>
                </a:r>
                <a:endParaRPr lang="en-US" sz="112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8FCD89D-A489-4221-B67B-EBCED2D0BC28}"/>
                </a:ext>
              </a:extLst>
            </p:cNvPr>
            <p:cNvSpPr txBox="1"/>
            <p:nvPr/>
          </p:nvSpPr>
          <p:spPr>
            <a:xfrm>
              <a:off x="14557640" y="127877"/>
              <a:ext cx="443608" cy="562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96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965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E002166-CC70-474F-BF56-D77381607CC2}"/>
                </a:ext>
              </a:extLst>
            </p:cNvPr>
            <p:cNvSpPr txBox="1"/>
            <p:nvPr/>
          </p:nvSpPr>
          <p:spPr>
            <a:xfrm>
              <a:off x="14557640" y="3883157"/>
              <a:ext cx="443608" cy="562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96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965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008255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AC2D2855-429B-4590-AED0-DEFC78E67C55}"/>
              </a:ext>
            </a:extLst>
          </p:cNvPr>
          <p:cNvSpPr/>
          <p:nvPr/>
        </p:nvSpPr>
        <p:spPr>
          <a:xfrm>
            <a:off x="0" y="5895840"/>
            <a:ext cx="12192000" cy="6753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Manhattan plots showing significant marker traits association and Quantile-Quantile (Q-Q) for Farm-CPU model for a) </a:t>
            </a:r>
            <a:r>
              <a:rPr lang="en-US" sz="1263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Me</a:t>
            </a:r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b)</a:t>
            </a:r>
            <a:r>
              <a:rPr lang="en-US" sz="1263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I_1A in 184 spring barley genotypes (P&lt;0.0001; -log10&gt; FDR). Red line represents the expected values.</a:t>
            </a:r>
          </a:p>
          <a:p>
            <a:endParaRPr lang="en-US" sz="126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B373BF6-FCF0-4733-89C7-A353C01D35DF}"/>
              </a:ext>
            </a:extLst>
          </p:cNvPr>
          <p:cNvGrpSpPr/>
          <p:nvPr/>
        </p:nvGrpSpPr>
        <p:grpSpPr>
          <a:xfrm>
            <a:off x="1393308" y="541422"/>
            <a:ext cx="9150682" cy="5320354"/>
            <a:chOff x="1985464" y="0"/>
            <a:chExt cx="13039721" cy="7581505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DDFD6FB6-3FA0-403C-9C8D-08087F919E79}"/>
                </a:ext>
              </a:extLst>
            </p:cNvPr>
            <p:cNvGrpSpPr/>
            <p:nvPr/>
          </p:nvGrpSpPr>
          <p:grpSpPr>
            <a:xfrm>
              <a:off x="1985464" y="0"/>
              <a:ext cx="12960315" cy="7581505"/>
              <a:chOff x="1985464" y="0"/>
              <a:chExt cx="12960315" cy="7581505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0AED234F-3C0C-4173-83DE-D4EA3F10389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345779" y="201505"/>
                <a:ext cx="3600000" cy="360000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A6A90428-1021-465C-AFED-23C9FA1B29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85464" y="0"/>
                <a:ext cx="9240000" cy="3960000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7BC72312-C952-49F2-84A5-C0AECAB37598}"/>
                  </a:ext>
                </a:extLst>
              </p:cNvPr>
              <p:cNvSpPr txBox="1"/>
              <p:nvPr/>
            </p:nvSpPr>
            <p:spPr>
              <a:xfrm>
                <a:off x="9802165" y="264695"/>
                <a:ext cx="697161" cy="377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23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e</a:t>
                </a:r>
                <a:endParaRPr lang="en-US" sz="112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2A6212E5-295B-4E58-A071-D84D1BF1AD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345779" y="3801505"/>
                <a:ext cx="3600000" cy="360000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63DD5C6D-78E6-43DB-97D8-0DEDE664F08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85464" y="3621505"/>
                <a:ext cx="9240000" cy="3960000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1B81AFC-EB04-4A84-AB2B-DC9A56CFC4CF}"/>
                  </a:ext>
                </a:extLst>
              </p:cNvPr>
              <p:cNvSpPr txBox="1"/>
              <p:nvPr/>
            </p:nvSpPr>
            <p:spPr>
              <a:xfrm>
                <a:off x="9552096" y="4055418"/>
                <a:ext cx="959854" cy="3778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23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I_1A</a:t>
                </a:r>
                <a:endParaRPr lang="en-US" sz="1123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C1C1414-5943-4385-B168-5E45888B7F7F}"/>
                </a:ext>
              </a:extLst>
            </p:cNvPr>
            <p:cNvSpPr txBox="1"/>
            <p:nvPr/>
          </p:nvSpPr>
          <p:spPr>
            <a:xfrm>
              <a:off x="14557640" y="127877"/>
              <a:ext cx="443608" cy="562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96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965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7C2F9C5-FC19-43C2-811B-47DF20C76C42}"/>
                </a:ext>
              </a:extLst>
            </p:cNvPr>
            <p:cNvSpPr txBox="1"/>
            <p:nvPr/>
          </p:nvSpPr>
          <p:spPr>
            <a:xfrm>
              <a:off x="14581577" y="3741021"/>
              <a:ext cx="443608" cy="5624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965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965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83777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31880AEC61F954E9318AA572AE84589" ma:contentTypeVersion="16" ma:contentTypeDescription="Create a new document." ma:contentTypeScope="" ma:versionID="1e88a95470a1248344e4b4ae198b7efa">
  <xsd:schema xmlns:xsd="http://www.w3.org/2001/XMLSchema" xmlns:xs="http://www.w3.org/2001/XMLSchema" xmlns:p="http://schemas.microsoft.com/office/2006/metadata/properties" xmlns:ns3="f324a0ff-5518-4b3f-8d0f-30c34c6d5dbf" xmlns:ns4="4cdd3259-2936-4fd9-b3ac-d1c48721ff82" targetNamespace="http://schemas.microsoft.com/office/2006/metadata/properties" ma:root="true" ma:fieldsID="503cc1cc46c8dcf060ddecc17b63c046" ns3:_="" ns4:_="">
    <xsd:import namespace="f324a0ff-5518-4b3f-8d0f-30c34c6d5dbf"/>
    <xsd:import namespace="4cdd3259-2936-4fd9-b3ac-d1c48721ff8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LengthInSeconds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324a0ff-5518-4b3f-8d0f-30c34c6d5db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LengthInSeconds" ma:index="1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6" nillable="true" ma:displayName="Location" ma:internalName="MediaServiceLocation" ma:readOnly="true">
      <xsd:simpleType>
        <xsd:restriction base="dms:Text"/>
      </xsd:simpleType>
    </xsd:element>
    <xsd:element name="_activity" ma:index="20" nillable="true" ma:displayName="_activity" ma:hidden="true" ma:internalName="_activity">
      <xsd:simpleType>
        <xsd:restriction base="dms:Note"/>
      </xsd:simpleType>
    </xsd:element>
    <xsd:element name="MediaServiceObjectDetectorVersions" ma:index="21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dd3259-2936-4fd9-b3ac-d1c48721ff82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324a0ff-5518-4b3f-8d0f-30c34c6d5dbf" xsi:nil="true"/>
  </documentManagement>
</p:properties>
</file>

<file path=customXml/itemProps1.xml><?xml version="1.0" encoding="utf-8"?>
<ds:datastoreItem xmlns:ds="http://schemas.openxmlformats.org/officeDocument/2006/customXml" ds:itemID="{5236B516-FFC1-4FDE-9339-CFC57468240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5039AF1E-C3CD-433E-8F0E-EC99CC68559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324a0ff-5518-4b3f-8d0f-30c34c6d5dbf"/>
    <ds:schemaRef ds:uri="4cdd3259-2936-4fd9-b3ac-d1c48721ff8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3DD6968-E26D-4B5A-BD22-28B93A961EC5}">
  <ds:schemaRefs>
    <ds:schemaRef ds:uri="4cdd3259-2936-4fd9-b3ac-d1c48721ff82"/>
    <ds:schemaRef ds:uri="http://www.w3.org/XML/1998/namespace"/>
    <ds:schemaRef ds:uri="f324a0ff-5518-4b3f-8d0f-30c34c6d5dbf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schemas.microsoft.com/office/infopath/2007/PartnerControls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84</TotalTime>
  <Words>308</Words>
  <Application>Microsoft Office PowerPoint</Application>
  <PresentationFormat>Widescreen</PresentationFormat>
  <Paragraphs>2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ad Mohammad I. Alqudah</dc:creator>
  <cp:lastModifiedBy>Ahmad Mohammad I. Alqudah</cp:lastModifiedBy>
  <cp:revision>2</cp:revision>
  <dcterms:created xsi:type="dcterms:W3CDTF">2024-08-08T20:02:45Z</dcterms:created>
  <dcterms:modified xsi:type="dcterms:W3CDTF">2024-08-18T15:49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31880AEC61F954E9318AA572AE84589</vt:lpwstr>
  </property>
</Properties>
</file>